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2835" autoAdjust="0"/>
    <p:restoredTop sz="94660"/>
  </p:normalViewPr>
  <p:slideViewPr>
    <p:cSldViewPr snapToGrid="0">
      <p:cViewPr varScale="1">
        <p:scale>
          <a:sx n="74" d="100"/>
          <a:sy n="74" d="100"/>
        </p:scale>
        <p:origin x="60" y="8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Before (N=86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A$2:$A$8</c:f>
              <c:strCache>
                <c:ptCount val="7"/>
                <c:pt idx="0">
                  <c:v>&lt;5</c:v>
                </c:pt>
                <c:pt idx="1">
                  <c:v>5 to  &lt;10</c:v>
                </c:pt>
                <c:pt idx="2">
                  <c:v>10 to &lt;15</c:v>
                </c:pt>
                <c:pt idx="3">
                  <c:v>15 to &lt;20</c:v>
                </c:pt>
                <c:pt idx="4">
                  <c:v>20 to &lt;25</c:v>
                </c:pt>
                <c:pt idx="5">
                  <c:v>25 to &lt;30</c:v>
                </c:pt>
                <c:pt idx="6">
                  <c:v>30 and more</c:v>
                </c:pt>
              </c:strCache>
            </c:strRef>
          </c:cat>
          <c:val>
            <c:numRef>
              <c:f>Sheet1!$B$2:$B$8</c:f>
              <c:numCache>
                <c:formatCode>0%</c:formatCode>
                <c:ptCount val="7"/>
                <c:pt idx="0">
                  <c:v>0.47674418604651164</c:v>
                </c:pt>
                <c:pt idx="1">
                  <c:v>0.12790697674418605</c:v>
                </c:pt>
                <c:pt idx="2">
                  <c:v>6.9767441860465115E-2</c:v>
                </c:pt>
                <c:pt idx="3">
                  <c:v>5.8139534883720929E-2</c:v>
                </c:pt>
                <c:pt idx="4">
                  <c:v>5.8139534883720929E-2</c:v>
                </c:pt>
                <c:pt idx="5">
                  <c:v>3.4883720930232558E-2</c:v>
                </c:pt>
                <c:pt idx="6">
                  <c:v>0.1511627906976744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B2F-492A-8A13-574664440455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After (N=154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A$2:$A$8</c:f>
              <c:strCache>
                <c:ptCount val="7"/>
                <c:pt idx="0">
                  <c:v>&lt;5</c:v>
                </c:pt>
                <c:pt idx="1">
                  <c:v>5 to  &lt;10</c:v>
                </c:pt>
                <c:pt idx="2">
                  <c:v>10 to &lt;15</c:v>
                </c:pt>
                <c:pt idx="3">
                  <c:v>15 to &lt;20</c:v>
                </c:pt>
                <c:pt idx="4">
                  <c:v>20 to &lt;25</c:v>
                </c:pt>
                <c:pt idx="5">
                  <c:v>25 to &lt;30</c:v>
                </c:pt>
                <c:pt idx="6">
                  <c:v>30 and more</c:v>
                </c:pt>
              </c:strCache>
            </c:strRef>
          </c:cat>
          <c:val>
            <c:numRef>
              <c:f>Sheet1!$C$2:$C$8</c:f>
              <c:numCache>
                <c:formatCode>0%</c:formatCode>
                <c:ptCount val="7"/>
                <c:pt idx="0">
                  <c:v>0.22077922077922077</c:v>
                </c:pt>
                <c:pt idx="1">
                  <c:v>5.1948051948051951E-2</c:v>
                </c:pt>
                <c:pt idx="2">
                  <c:v>9.0909090909090912E-2</c:v>
                </c:pt>
                <c:pt idx="3">
                  <c:v>7.1428571428571425E-2</c:v>
                </c:pt>
                <c:pt idx="4">
                  <c:v>5.1948051948051951E-2</c:v>
                </c:pt>
                <c:pt idx="5">
                  <c:v>6.4935064935064929E-2</c:v>
                </c:pt>
                <c:pt idx="6">
                  <c:v>0.4480519480519481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CB2F-492A-8A13-57466444045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113716368"/>
        <c:axId val="-2113704400"/>
      </c:barChart>
      <c:catAx>
        <c:axId val="-21137163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113704400"/>
        <c:crosses val="autoZero"/>
        <c:auto val="1"/>
        <c:lblAlgn val="ctr"/>
        <c:lblOffset val="100"/>
        <c:noMultiLvlLbl val="0"/>
      </c:catAx>
      <c:valAx>
        <c:axId val="-2113704400"/>
        <c:scaling>
          <c:orientation val="minMax"/>
          <c:max val="0.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113716368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3359495762140406"/>
          <c:y val="6.5316461281564361E-2"/>
          <c:w val="0.30536168774357753"/>
          <c:h val="6.200943250099164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226EF7E2-94DF-E148-4449-58518FB5A52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xmlns="" id="{9C55CF20-87B3-2998-FC42-1F2B4F3290F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487C17EB-5191-B6BB-F820-68FD8CB2FB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78919-92D4-4C5B-A346-20794416BEF1}" type="datetimeFigureOut">
              <a:rPr kumimoji="1" lang="ja-JP" altLang="en-US" smtClean="0"/>
              <a:t>2023/3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506C2E65-5F2A-B978-EB46-A9336B1D9D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79EA4522-04B0-29E5-1FEC-9A229783FD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8EAE7-33D7-437E-85AF-AB106DFBB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14473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7E6DA5F6-CFAA-8549-CBD9-FC7A384B83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BA03EBE0-1052-D61A-2077-CA22E75057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49DE346F-2A06-830C-4B69-F7E14F2AA0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78919-92D4-4C5B-A346-20794416BEF1}" type="datetimeFigureOut">
              <a:rPr kumimoji="1" lang="ja-JP" altLang="en-US" smtClean="0"/>
              <a:t>2023/3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9A0A8E0A-633A-8C2A-D606-F717D56C4F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5B2B7273-9EEE-84D7-B789-841A5A0458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8EAE7-33D7-437E-85AF-AB106DFBB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15335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xmlns="" id="{10F8C0AA-93D0-553C-1DD9-296A4AC8784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85B61B0D-A129-E281-35DF-DF8B698853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A7E98F11-2B14-8623-0DF5-A7FE49B427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78919-92D4-4C5B-A346-20794416BEF1}" type="datetimeFigureOut">
              <a:rPr kumimoji="1" lang="ja-JP" altLang="en-US" smtClean="0"/>
              <a:t>2023/3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8B5606F6-6FC9-0789-0625-8534E5F1F7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478A5D7E-DBAB-90D8-E223-5D1FDDD529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8EAE7-33D7-437E-85AF-AB106DFBB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4452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DFEE0840-E972-039A-AFD7-F4A04C8639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C10AC413-1AA6-B30F-B61A-48A8D32166C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C744CDD7-601B-2904-B1FC-8DF8581CDC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78919-92D4-4C5B-A346-20794416BEF1}" type="datetimeFigureOut">
              <a:rPr kumimoji="1" lang="ja-JP" altLang="en-US" smtClean="0"/>
              <a:t>2023/3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0F4F7A37-226F-07E4-7792-044701B0E5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7284D0A1-06DF-8955-F669-2BA70FB50D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8EAE7-33D7-437E-85AF-AB106DFBB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79323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CF8D9746-BD4C-8904-1F05-9C8721B959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28F87777-D943-B1A6-4A62-C16360802D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F20C8EFA-0F92-F7AE-9877-CB90AE6423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78919-92D4-4C5B-A346-20794416BEF1}" type="datetimeFigureOut">
              <a:rPr kumimoji="1" lang="ja-JP" altLang="en-US" smtClean="0"/>
              <a:t>2023/3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3DFEAC51-9440-5221-7AE6-72839EA5E0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99659B35-0A50-538D-0FF6-D36A5FB638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8EAE7-33D7-437E-85AF-AB106DFBB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5935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D0E5DA0F-0EF5-77C6-5CC0-2B06A5A5EB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CB63967F-2132-D254-D7C9-1A647124D5D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CF89845D-AC21-6C6F-DD79-47D1AD78193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0B3CF201-CFE1-E16A-4D3A-BD1BE8DD65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78919-92D4-4C5B-A346-20794416BEF1}" type="datetimeFigureOut">
              <a:rPr kumimoji="1" lang="ja-JP" altLang="en-US" smtClean="0"/>
              <a:t>2023/3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8C9A9312-823C-7E77-E6D6-C0E0CA3FC1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FEA2CD7B-2AA0-85E7-0204-FA090AFFE4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8EAE7-33D7-437E-85AF-AB106DFBB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876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DB8E4D2F-720E-5133-7930-DBCB3FEF8A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3D258908-55B7-7B1C-FEB0-416F6AC318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ACFD2363-DC8C-3B06-37C4-74CB9A5423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xmlns="" id="{E2F862F4-1A44-BE83-9A30-3EA598E7460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xmlns="" id="{3270E17E-D496-5DB0-75E6-977EA345EE9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xmlns="" id="{8F2EAEBB-355B-81EB-1E70-93E554B111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78919-92D4-4C5B-A346-20794416BEF1}" type="datetimeFigureOut">
              <a:rPr kumimoji="1" lang="ja-JP" altLang="en-US" smtClean="0"/>
              <a:t>2023/3/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xmlns="" id="{9C2969CB-BE2E-336A-FCD1-579BC6829D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xmlns="" id="{EFB2B731-4F6C-9890-D389-027E331D9E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8EAE7-33D7-437E-85AF-AB106DFBB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05844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3BF5B6D4-E870-45AA-DAFC-2494DF951D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xmlns="" id="{A7BD5C7C-1863-339D-DAD1-4D8F9F515B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78919-92D4-4C5B-A346-20794416BEF1}" type="datetimeFigureOut">
              <a:rPr kumimoji="1" lang="ja-JP" altLang="en-US" smtClean="0"/>
              <a:t>2023/3/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xmlns="" id="{6832FD8A-986F-21F5-4C7B-F31B1564D8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xmlns="" id="{429A14A8-DDC2-A4FE-87BE-54B9A71219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8EAE7-33D7-437E-85AF-AB106DFBB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2945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xmlns="" id="{D206B226-664D-FFC9-581C-6CAC546FB8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78919-92D4-4C5B-A346-20794416BEF1}" type="datetimeFigureOut">
              <a:rPr kumimoji="1" lang="ja-JP" altLang="en-US" smtClean="0"/>
              <a:t>2023/3/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xmlns="" id="{40FFAAC9-A6B1-6A4E-F459-A8902D7013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xmlns="" id="{A88A7851-BC19-74CB-E59A-BDA21D65BC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8EAE7-33D7-437E-85AF-AB106DFBB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46003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D8DF8542-6276-A2FA-28E7-EFB04D87CF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4CF3D78E-C4AA-8986-8B4D-971D656A6AE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CC6BC563-8565-3813-105C-8213F80F22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BCAD63EF-1958-12F3-FBAF-2C7193879F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78919-92D4-4C5B-A346-20794416BEF1}" type="datetimeFigureOut">
              <a:rPr kumimoji="1" lang="ja-JP" altLang="en-US" smtClean="0"/>
              <a:t>2023/3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A2DEB2AD-1068-4CF6-AF37-B8A96F466B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6F0C6EBC-9F47-0FD2-8C6F-8C74C18707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8EAE7-33D7-437E-85AF-AB106DFBB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60040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24007065-F4DF-F55C-C296-241A9F4A91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xmlns="" id="{5576738C-ED5E-9AE7-F114-137F9585F41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37123CE7-4293-0F08-9AD6-F6F25F3E7C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3B833B16-BB8C-4642-145C-6ACC924748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78919-92D4-4C5B-A346-20794416BEF1}" type="datetimeFigureOut">
              <a:rPr kumimoji="1" lang="ja-JP" altLang="en-US" smtClean="0"/>
              <a:t>2023/3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1B667891-3F02-AFF5-E530-034E8D9E61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F72DD223-4EC2-5CA6-6FA4-47896877B8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8EAE7-33D7-437E-85AF-AB106DFBB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94522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xmlns="" id="{704F8782-D7E1-B69F-EF8F-1418C1073B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C92CDFD7-681E-FE15-FE4E-8B8A5EB3A6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32757C70-9D8D-E277-51F4-99876247D59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278919-92D4-4C5B-A346-20794416BEF1}" type="datetimeFigureOut">
              <a:rPr kumimoji="1" lang="ja-JP" altLang="en-US" smtClean="0"/>
              <a:t>2023/3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BEC33461-6663-5A41-0B54-D95CC0EA79E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2139C043-059A-046F-C93C-EF9EA74A5A2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88EAE7-33D7-437E-85AF-AB106DFBB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73833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タイトル 3">
            <a:extLst>
              <a:ext uri="{FF2B5EF4-FFF2-40B4-BE49-F238E27FC236}">
                <a16:creationId xmlns:a16="http://schemas.microsoft.com/office/drawing/2014/main" xmlns="" id="{A5BE000B-A44A-4725-B530-6C806D8103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10894" y="681037"/>
            <a:ext cx="9792260" cy="693113"/>
          </a:xfrm>
        </p:spPr>
        <p:txBody>
          <a:bodyPr>
            <a:noAutofit/>
          </a:bodyPr>
          <a:lstStyle/>
          <a:p>
            <a:r>
              <a:rPr lang="en-US" altLang="ja-JP" sz="2000" smtClean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b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Distribution of LOS in high risk patients before and after the Tele-ICU implementation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コンテンツ プレースホルダー 7">
            <a:extLst>
              <a:ext uri="{FF2B5EF4-FFF2-40B4-BE49-F238E27FC236}">
                <a16:creationId xmlns:a16="http://schemas.microsoft.com/office/drawing/2014/main" xmlns="" id="{5BBEC369-243C-76AC-6A61-7ED20144FA6C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063941549"/>
              </p:ext>
            </p:extLst>
          </p:nvPr>
        </p:nvGraphicFramePr>
        <p:xfrm>
          <a:off x="1280160" y="1825625"/>
          <a:ext cx="9253728" cy="4351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8514F7C5-DC57-4AEC-2F77-71DDA5FDADB9}"/>
              </a:ext>
            </a:extLst>
          </p:cNvPr>
          <p:cNvSpPr txBox="1"/>
          <p:nvPr/>
        </p:nvSpPr>
        <p:spPr>
          <a:xfrm>
            <a:off x="3107988" y="5946130"/>
            <a:ext cx="5767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/>
              <a:t>Actual Hospital LOS (days)</a:t>
            </a:r>
            <a:endParaRPr kumimoji="1" lang="ja-JP" altLang="en-US" sz="1200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4EF987BC-C46B-3B4D-23BC-490F7020DF17}"/>
              </a:ext>
            </a:extLst>
          </p:cNvPr>
          <p:cNvSpPr txBox="1"/>
          <p:nvPr/>
        </p:nvSpPr>
        <p:spPr>
          <a:xfrm rot="16200000">
            <a:off x="-458258" y="3564648"/>
            <a:ext cx="26613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Proportion (%) in high risk patients</a:t>
            </a:r>
            <a:endParaRPr kumimoji="1" lang="ja-JP" altLang="en-US" sz="1200"/>
          </a:p>
        </p:txBody>
      </p:sp>
    </p:spTree>
    <p:extLst>
      <p:ext uri="{BB962C8B-B14F-4D97-AF65-F5344CB8AC3E}">
        <p14:creationId xmlns:p14="http://schemas.microsoft.com/office/powerpoint/2010/main" val="11054150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14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Additional data Distribution of LOS in high risk patients before and after the Tele-ICU implem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ICU導入前後の入院期間の患者推移</dc:title>
  <dc:creator>Taro Watanabe</dc:creator>
  <cp:lastModifiedBy>Radha S</cp:lastModifiedBy>
  <cp:revision>7</cp:revision>
  <dcterms:created xsi:type="dcterms:W3CDTF">2023-02-05T11:31:39Z</dcterms:created>
  <dcterms:modified xsi:type="dcterms:W3CDTF">2023-03-03T01:36:39Z</dcterms:modified>
</cp:coreProperties>
</file>